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2" r:id="rId2"/>
    <p:sldId id="273" r:id="rId3"/>
    <p:sldId id="274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1395" autoAdjust="0"/>
  </p:normalViewPr>
  <p:slideViewPr>
    <p:cSldViewPr snapToGrid="0">
      <p:cViewPr varScale="1">
        <p:scale>
          <a:sx n="77" d="100"/>
          <a:sy n="77" d="100"/>
        </p:scale>
        <p:origin x="864" y="72"/>
      </p:cViewPr>
      <p:guideLst/>
    </p:cSldViewPr>
  </p:slideViewPr>
  <p:notesTextViewPr>
    <p:cViewPr>
      <p:scale>
        <a:sx n="3" d="2"/>
        <a:sy n="3" d="2"/>
      </p:scale>
      <p:origin x="0" y="-5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DDCD9D-CD52-4E39-AFE2-D755A7BCCA0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E6C55A-296A-4AF2-A239-6A394BD2EF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4944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ur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13FEB7E2-A352-4415-BC3C-51755FD73E98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071521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ure 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E6C55A-296A-4AF2-A239-6A394BD2EF8D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12785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ure S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E6C55A-296A-4AF2-A239-6A394BD2EF8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711689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ure S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E6C55A-296A-4AF2-A239-6A394BD2EF8D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1266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8C76BE-F61A-4BD7-960C-E5645AD1AB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191A0A-1AF5-4D66-B8EF-4138B8B5F9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0E43E9-4998-4D16-878A-53517FCC1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E32114-BF53-49EC-905C-12CA47EFE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6ACFC0-1A73-4307-8671-C7AA566A5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7542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EECE6E-C701-4F8C-8F09-3DDDDBEC1F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06B7F7-D414-4D3A-A32E-0CA2A6CAA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3E5187-950D-432B-AD5C-2DD2963D3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7941C2-612C-4A04-9E14-89FC4BB86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DB644F-6267-4FB6-B53F-335ED4E05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549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213AE6-6D06-4E79-923F-1C85F86994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113C90-6F8C-4462-9C0C-DD2A0BEAFB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654CDC-540A-41AD-97EB-515590271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57AB0B-1F4E-408A-AA7E-8FD07D851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127DB-FB13-4BA9-B663-A4FF69E4A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1706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D2C2F5-03E7-4DB0-8E38-622DD9445A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1A7F83-D7FD-4F25-A77E-567BFACCE9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68A0EF-8A7E-42D7-A5FD-F4D9A390A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62E787-B4BE-4D9B-AF39-CB5971A24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7A1BC5-FFEE-494A-B866-B5C9AB02A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5250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A797BC-8F15-4BF4-81DD-43D52DD3E7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D58AB7-3DC1-4705-B282-568E9AFDE8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28F2B7-9F3A-4770-B2F8-7E968756E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F5A5B4-7789-49B0-BEED-2462C3F2B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C76217-0B78-433F-9A2B-8D4726E8E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1101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21EB35-4E5F-4DBA-A7C9-7F144A0B7E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697B85-FDFB-41D2-AB88-5AF77C6E20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424DEE-BC0C-4E7E-BDFB-20FF76BA90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513EE1-83D1-4D81-8194-9541F934D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4A8247-F0D1-4C29-ADC0-210199891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852275-7515-433B-8FDE-4A6C8C659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584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98587-CEE4-40D9-8B0A-D0E68C8F92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7BDD2E-BE4A-4A31-B1F9-F178EDF53A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27323E-ED07-42A6-9606-8898DAD9FD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776B84-320B-4F88-A6B1-5160F94C6D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495C3D-9965-46EE-8338-32D4D29C8F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5EBC40-0BB6-4702-9CEF-923A99A05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D51EA8-C0F0-45F5-96F9-E803B2255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E0B422-2432-4261-A2F4-F69742A5C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0811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C58295-9F7E-4BAB-860B-9DF5E31A5F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FE9B18-8DA7-47D9-A079-62CE5AF08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92E5FE-4D12-4EBC-9057-0B638951E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3F06D9-8AC0-40EA-B57B-8AC513ACF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733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A4CECD-573F-418C-BC62-EE28C00F9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00C7AF-BCB8-446F-BC6F-56C7EB383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DA2B3A-00AB-4144-A0AA-CAA727636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6648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161FD1-453D-4DF0-B9D9-E9AA28EEE2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E22E36-D84A-40E5-A648-352A7F71A5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A0482D-873A-4367-A201-949A71F8EB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88B3CC-7D58-41AB-8551-C059896CD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755AE8-B191-467C-8447-D02E00AC8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6CBF58-50D6-4221-B5C6-A70762817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598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B22BB-009C-4FC5-BC06-7FF20AD00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9C9A4D-E0B9-4F24-B9C2-4C4110022E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BE3458-C40A-4087-90BA-7549464604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DC1A44-7AB3-46C7-AA65-7811EC8AE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593353-3A41-4D7E-AC4C-4BA0A5180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007AFB-C9C2-44DA-A71C-03E14680F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707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0CF51B-AB94-45E3-A304-93C5B98FDA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A17C98-9D12-46D8-9936-BFA1CE722E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30EA1E-E3AD-4494-9455-00759A3B22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E24975-5F63-49D2-A87A-8413FA41DD7F}" type="datetimeFigureOut">
              <a:rPr lang="en-GB" smtClean="0"/>
              <a:t>16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80C224-EAB2-47AC-8B85-E098CC61A1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E8ABC1-6275-465F-A75B-EBA37A58D3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D6ABD-332F-45EA-B744-C6CED990B1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5100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79042AFA-3C35-2C28-F59D-CED946365FDB}"/>
              </a:ext>
            </a:extLst>
          </p:cNvPr>
          <p:cNvGrpSpPr/>
          <p:nvPr/>
        </p:nvGrpSpPr>
        <p:grpSpPr>
          <a:xfrm>
            <a:off x="955863" y="114300"/>
            <a:ext cx="10280273" cy="6629400"/>
            <a:chOff x="80847" y="-774848"/>
            <a:chExt cx="10873208" cy="7876256"/>
          </a:xfrm>
        </p:grpSpPr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6D4256A4-784E-4864-BB38-DAE05F454CBE}"/>
                </a:ext>
              </a:extLst>
            </p:cNvPr>
            <p:cNvSpPr/>
            <p:nvPr/>
          </p:nvSpPr>
          <p:spPr>
            <a:xfrm>
              <a:off x="80847" y="-774848"/>
              <a:ext cx="10873208" cy="787625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1730CC8-13C8-3DFD-0A4B-108CA242B2AC}"/>
                </a:ext>
              </a:extLst>
            </p:cNvPr>
            <p:cNvGrpSpPr/>
            <p:nvPr/>
          </p:nvGrpSpPr>
          <p:grpSpPr>
            <a:xfrm>
              <a:off x="258396" y="-660931"/>
              <a:ext cx="10518124" cy="7614369"/>
              <a:chOff x="258396" y="-660931"/>
              <a:chExt cx="10518124" cy="7614369"/>
            </a:xfrm>
          </p:grpSpPr>
          <p:sp>
            <p:nvSpPr>
              <p:cNvPr id="40" name="Rounded Rectangle 22">
                <a:extLst>
                  <a:ext uri="{FF2B5EF4-FFF2-40B4-BE49-F238E27FC236}">
                    <a16:creationId xmlns:a16="http://schemas.microsoft.com/office/drawing/2014/main" id="{1A4AC3E0-3EA7-4F65-BFA9-17F85620A168}"/>
                  </a:ext>
                </a:extLst>
              </p:cNvPr>
              <p:cNvSpPr/>
              <p:nvPr/>
            </p:nvSpPr>
            <p:spPr>
              <a:xfrm>
                <a:off x="627796" y="3916936"/>
                <a:ext cx="5726125" cy="1033164"/>
              </a:xfrm>
              <a:prstGeom prst="roundRect">
                <a:avLst/>
              </a:prstGeom>
              <a:solidFill>
                <a:srgbClr val="ED51B9">
                  <a:alpha val="57000"/>
                </a:srgbClr>
              </a:solidFill>
              <a:ln>
                <a:solidFill>
                  <a:srgbClr val="DC2C88"/>
                </a:solidFill>
                <a:prstDash val="dash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 pitchFamily="34" charset="0"/>
                  <a:ea typeface="+mn-ea"/>
                  <a:cs typeface="+mn-cs"/>
                </a:endParaRPr>
              </a:p>
            </p:txBody>
          </p:sp>
          <p:sp>
            <p:nvSpPr>
              <p:cNvPr id="4" name="Rounded Rectangle 3">
                <a:extLst>
                  <a:ext uri="{FF2B5EF4-FFF2-40B4-BE49-F238E27FC236}">
                    <a16:creationId xmlns:a16="http://schemas.microsoft.com/office/drawing/2014/main" id="{443DED40-0E60-4363-8A74-A04BDECFC9AD}"/>
                  </a:ext>
                </a:extLst>
              </p:cNvPr>
              <p:cNvSpPr/>
              <p:nvPr/>
            </p:nvSpPr>
            <p:spPr>
              <a:xfrm>
                <a:off x="258396" y="652777"/>
                <a:ext cx="10518119" cy="372675"/>
              </a:xfrm>
              <a:prstGeom prst="round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HER2 negative locally advanced or metastatic </a:t>
                </a:r>
                <a:r>
                  <a:rPr kumimoji="0" lang="en-GB" sz="18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oesophago</a:t>
                </a: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-gastric adenocarcinoma</a:t>
                </a:r>
              </a:p>
            </p:txBody>
          </p:sp>
          <p:sp>
            <p:nvSpPr>
              <p:cNvPr id="5" name="Rounded Rectangle 4">
                <a:extLst>
                  <a:ext uri="{FF2B5EF4-FFF2-40B4-BE49-F238E27FC236}">
                    <a16:creationId xmlns:a16="http://schemas.microsoft.com/office/drawing/2014/main" id="{C6A5753B-436E-4646-9A6C-B8E111531581}"/>
                  </a:ext>
                </a:extLst>
              </p:cNvPr>
              <p:cNvSpPr/>
              <p:nvPr/>
            </p:nvSpPr>
            <p:spPr>
              <a:xfrm>
                <a:off x="2999656" y="-660931"/>
                <a:ext cx="7776864" cy="1238220"/>
              </a:xfrm>
              <a:prstGeom prst="round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Key eligibility criteria:</a:t>
                </a:r>
              </a:p>
              <a:p>
                <a:pPr marL="285750" marR="0" lvl="0" indent="-2857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  <a:defRPr/>
                </a:pPr>
                <a:r>
                  <a:rPr kumimoji="0" lang="en-GB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Inoperable, locally advanced or metastatic adenocarcinoma of the oesophagus, GOJ or stomach</a:t>
                </a:r>
              </a:p>
              <a:p>
                <a:pPr marL="285750" marR="0" lvl="0" indent="-2857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  <a:defRPr/>
                </a:pPr>
                <a:r>
                  <a:rPr kumimoji="0" lang="en-GB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Completion of 18 weeks of platinum-fluoropyrimidine chemotherapy</a:t>
                </a:r>
              </a:p>
              <a:p>
                <a:pPr marL="285750" marR="0" lvl="0" indent="-2857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  <a:defRPr/>
                </a:pPr>
                <a:r>
                  <a:rPr kumimoji="0" lang="en-GB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Stable disease or response</a:t>
                </a:r>
              </a:p>
              <a:p>
                <a:pPr marL="285750" marR="0" lvl="0" indent="-28575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 typeface="Arial" panose="020B0604020202020204" pitchFamily="34" charset="0"/>
                  <a:buChar char="•"/>
                  <a:tabLst/>
                  <a:defRPr/>
                </a:pPr>
                <a:r>
                  <a:rPr kumimoji="0" lang="en-GB" sz="13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PS 0-2</a:t>
                </a:r>
              </a:p>
            </p:txBody>
          </p:sp>
          <p:sp>
            <p:nvSpPr>
              <p:cNvPr id="13" name="Rounded Rectangle 12">
                <a:extLst>
                  <a:ext uri="{FF2B5EF4-FFF2-40B4-BE49-F238E27FC236}">
                    <a16:creationId xmlns:a16="http://schemas.microsoft.com/office/drawing/2014/main" id="{E4E79043-2993-46EF-8BDC-E56C02D329CA}"/>
                  </a:ext>
                </a:extLst>
              </p:cNvPr>
              <p:cNvSpPr/>
              <p:nvPr/>
            </p:nvSpPr>
            <p:spPr>
              <a:xfrm>
                <a:off x="3836030" y="2516255"/>
                <a:ext cx="3025421" cy="477480"/>
              </a:xfrm>
              <a:prstGeom prst="roundRect">
                <a:avLst/>
              </a:prstGeom>
              <a:solidFill>
                <a:srgbClr val="55CBBD"/>
              </a:solidFill>
              <a:ln>
                <a:solidFill>
                  <a:srgbClr val="2F998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≥ SD on CT</a:t>
                </a:r>
              </a:p>
            </p:txBody>
          </p:sp>
          <p:sp>
            <p:nvSpPr>
              <p:cNvPr id="15" name="Oval 14">
                <a:extLst>
                  <a:ext uri="{FF2B5EF4-FFF2-40B4-BE49-F238E27FC236}">
                    <a16:creationId xmlns:a16="http://schemas.microsoft.com/office/drawing/2014/main" id="{3B687946-256D-42CC-8CCE-B3809A00AF10}"/>
                  </a:ext>
                </a:extLst>
              </p:cNvPr>
              <p:cNvSpPr/>
              <p:nvPr/>
            </p:nvSpPr>
            <p:spPr>
              <a:xfrm>
                <a:off x="5193751" y="3273131"/>
                <a:ext cx="341421" cy="333955"/>
              </a:xfrm>
              <a:prstGeom prst="ellipse">
                <a:avLst/>
              </a:prstGeom>
              <a:solidFill>
                <a:srgbClr val="DF6F9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R</a:t>
                </a: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B28F948C-FDB2-44E3-ACD9-2B51991776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8007" y="2999234"/>
                <a:ext cx="0" cy="273897"/>
              </a:xfrm>
              <a:prstGeom prst="line">
                <a:avLst/>
              </a:prstGeom>
              <a:ln w="25400">
                <a:solidFill>
                  <a:srgbClr val="CD2DA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6DC49CCE-4E9D-47B8-BCC8-1F80E8BFDB03}"/>
                  </a:ext>
                </a:extLst>
              </p:cNvPr>
              <p:cNvGrpSpPr/>
              <p:nvPr/>
            </p:nvGrpSpPr>
            <p:grpSpPr>
              <a:xfrm>
                <a:off x="767408" y="4051433"/>
                <a:ext cx="9220432" cy="800635"/>
                <a:chOff x="168268" y="2983398"/>
                <a:chExt cx="8709590" cy="806834"/>
              </a:xfrm>
              <a:solidFill>
                <a:srgbClr val="55CBBD"/>
              </a:solidFill>
            </p:grpSpPr>
            <p:sp>
              <p:nvSpPr>
                <p:cNvPr id="22" name="Rounded Rectangle 21">
                  <a:extLst>
                    <a:ext uri="{FF2B5EF4-FFF2-40B4-BE49-F238E27FC236}">
                      <a16:creationId xmlns:a16="http://schemas.microsoft.com/office/drawing/2014/main" id="{FA60D750-B154-4634-82AC-73B52F8C8E43}"/>
                    </a:ext>
                  </a:extLst>
                </p:cNvPr>
                <p:cNvSpPr/>
                <p:nvPr/>
              </p:nvSpPr>
              <p:spPr>
                <a:xfrm>
                  <a:off x="168268" y="3021509"/>
                  <a:ext cx="1499627" cy="768723"/>
                </a:xfrm>
                <a:prstGeom prst="roundRect">
                  <a:avLst/>
                </a:prstGeom>
                <a:grpFill/>
                <a:ln w="12700">
                  <a:solidFill>
                    <a:schemeClr val="accent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+mn-ea"/>
                      <a:cs typeface="+mn-cs"/>
                    </a:rPr>
                    <a:t>A1: Surveillance</a:t>
                  </a:r>
                </a:p>
              </p:txBody>
            </p:sp>
            <p:sp>
              <p:nvSpPr>
                <p:cNvPr id="23" name="Rounded Rectangle 22">
                  <a:extLst>
                    <a:ext uri="{FF2B5EF4-FFF2-40B4-BE49-F238E27FC236}">
                      <a16:creationId xmlns:a16="http://schemas.microsoft.com/office/drawing/2014/main" id="{E23FFF53-F23B-4D42-AEC4-44A8CC21363B}"/>
                    </a:ext>
                  </a:extLst>
                </p:cNvPr>
                <p:cNvSpPr/>
                <p:nvPr/>
              </p:nvSpPr>
              <p:spPr>
                <a:xfrm>
                  <a:off x="2001548" y="3009236"/>
                  <a:ext cx="1499627" cy="768723"/>
                </a:xfrm>
                <a:prstGeom prst="roundRect">
                  <a:avLst/>
                </a:prstGeom>
                <a:grpFill/>
                <a:ln w="12700">
                  <a:solidFill>
                    <a:schemeClr val="accent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+mn-ea"/>
                      <a:cs typeface="+mn-cs"/>
                    </a:rPr>
                    <a:t>A2: Capecitabine</a:t>
                  </a:r>
                </a:p>
              </p:txBody>
            </p:sp>
            <p:sp>
              <p:nvSpPr>
                <p:cNvPr id="24" name="Rounded Rectangle 23">
                  <a:extLst>
                    <a:ext uri="{FF2B5EF4-FFF2-40B4-BE49-F238E27FC236}">
                      <a16:creationId xmlns:a16="http://schemas.microsoft.com/office/drawing/2014/main" id="{A1CD4A38-C37F-431C-8F1A-5513FDF5F385}"/>
                    </a:ext>
                  </a:extLst>
                </p:cNvPr>
                <p:cNvSpPr/>
                <p:nvPr/>
              </p:nvSpPr>
              <p:spPr>
                <a:xfrm>
                  <a:off x="3770029" y="3003571"/>
                  <a:ext cx="1499627" cy="768723"/>
                </a:xfrm>
                <a:prstGeom prst="roundRect">
                  <a:avLst/>
                </a:prstGeom>
                <a:grpFill/>
                <a:ln w="12700">
                  <a:solidFill>
                    <a:schemeClr val="accent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+mn-ea"/>
                      <a:cs typeface="+mn-cs"/>
                    </a:rPr>
                    <a:t>A3: Durvalumab</a:t>
                  </a:r>
                </a:p>
              </p:txBody>
            </p:sp>
            <p:sp>
              <p:nvSpPr>
                <p:cNvPr id="25" name="Rounded Rectangle 24">
                  <a:extLst>
                    <a:ext uri="{FF2B5EF4-FFF2-40B4-BE49-F238E27FC236}">
                      <a16:creationId xmlns:a16="http://schemas.microsoft.com/office/drawing/2014/main" id="{AEB37427-DC44-4FA1-B8A1-CCD5E15E7131}"/>
                    </a:ext>
                  </a:extLst>
                </p:cNvPr>
                <p:cNvSpPr/>
                <p:nvPr/>
              </p:nvSpPr>
              <p:spPr>
                <a:xfrm>
                  <a:off x="5541730" y="2989102"/>
                  <a:ext cx="1499627" cy="768723"/>
                </a:xfrm>
                <a:prstGeom prst="roundRect">
                  <a:avLst/>
                </a:prstGeom>
                <a:grpFill/>
                <a:ln w="12700">
                  <a:solidFill>
                    <a:schemeClr val="accent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+mn-ea"/>
                      <a:cs typeface="+mn-cs"/>
                    </a:rPr>
                    <a:t>A4: </a:t>
                  </a:r>
                </a:p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+mn-ea"/>
                      <a:cs typeface="+mn-cs"/>
                    </a:rPr>
                    <a:t>Rucaparib</a:t>
                  </a:r>
                </a:p>
              </p:txBody>
            </p:sp>
            <p:sp>
              <p:nvSpPr>
                <p:cNvPr id="26" name="Rounded Rectangle 25">
                  <a:extLst>
                    <a:ext uri="{FF2B5EF4-FFF2-40B4-BE49-F238E27FC236}">
                      <a16:creationId xmlns:a16="http://schemas.microsoft.com/office/drawing/2014/main" id="{6E2A7A1F-CC57-433B-B1E7-BBF1E81A4D96}"/>
                    </a:ext>
                  </a:extLst>
                </p:cNvPr>
                <p:cNvSpPr/>
                <p:nvPr/>
              </p:nvSpPr>
              <p:spPr>
                <a:xfrm>
                  <a:off x="7378231" y="2983398"/>
                  <a:ext cx="1499627" cy="768723"/>
                </a:xfrm>
                <a:prstGeom prst="roundRect">
                  <a:avLst/>
                </a:prstGeom>
                <a:grpFill/>
                <a:ln w="12700">
                  <a:solidFill>
                    <a:schemeClr val="accent3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GB" sz="1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+mn-ea"/>
                      <a:cs typeface="+mn-cs"/>
                    </a:rPr>
                    <a:t>A5: Capecitabine + ramucirumab</a:t>
                  </a:r>
                </a:p>
              </p:txBody>
            </p:sp>
          </p:grp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A4E7D6BA-71C5-4D7B-8ECD-52A01B0D41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59496" y="3799898"/>
                <a:ext cx="7704856" cy="0"/>
              </a:xfrm>
              <a:prstGeom prst="line">
                <a:avLst/>
              </a:prstGeom>
              <a:ln w="25400">
                <a:solidFill>
                  <a:srgbClr val="CC2E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2DD5969C-8EF5-4373-B7D7-B15B1E83B0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59496" y="3799898"/>
                <a:ext cx="0" cy="271954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A2871582-5496-490B-B9A2-DF61D71A63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8024" y="3609555"/>
                <a:ext cx="7897" cy="463735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8B8C45B9-5B5F-4EDB-837E-B915C3AF47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64352" y="3799898"/>
                <a:ext cx="0" cy="255770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Arrow Connector 35">
                <a:extLst>
                  <a:ext uri="{FF2B5EF4-FFF2-40B4-BE49-F238E27FC236}">
                    <a16:creationId xmlns:a16="http://schemas.microsoft.com/office/drawing/2014/main" id="{4CF03962-0370-4E78-A7F8-C038217EC7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1704" y="3799898"/>
                <a:ext cx="0" cy="289352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>
                <a:extLst>
                  <a:ext uri="{FF2B5EF4-FFF2-40B4-BE49-F238E27FC236}">
                    <a16:creationId xmlns:a16="http://schemas.microsoft.com/office/drawing/2014/main" id="{2646590B-15A0-45DB-B9D8-1535E60B7221}"/>
                  </a:ext>
                </a:extLst>
              </p:cNvPr>
              <p:cNvCxnSpPr/>
              <p:nvPr/>
            </p:nvCxnSpPr>
            <p:spPr>
              <a:xfrm flipH="1">
                <a:off x="7320136" y="3799899"/>
                <a:ext cx="1332" cy="246823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Rounded Rectangle 56">
                <a:extLst>
                  <a:ext uri="{FF2B5EF4-FFF2-40B4-BE49-F238E27FC236}">
                    <a16:creationId xmlns:a16="http://schemas.microsoft.com/office/drawing/2014/main" id="{81D6B075-63D2-463A-9707-D3CFA87FF72F}"/>
                  </a:ext>
                </a:extLst>
              </p:cNvPr>
              <p:cNvSpPr/>
              <p:nvPr/>
            </p:nvSpPr>
            <p:spPr>
              <a:xfrm>
                <a:off x="258396" y="5589241"/>
                <a:ext cx="10518113" cy="372675"/>
              </a:xfrm>
              <a:prstGeom prst="round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Disease progression</a:t>
                </a:r>
              </a:p>
            </p:txBody>
          </p:sp>
          <p:sp>
            <p:nvSpPr>
              <p:cNvPr id="58" name="Rounded Rectangle 57">
                <a:extLst>
                  <a:ext uri="{FF2B5EF4-FFF2-40B4-BE49-F238E27FC236}">
                    <a16:creationId xmlns:a16="http://schemas.microsoft.com/office/drawing/2014/main" id="{53EC39EF-5F7D-4D40-872B-AAD4AB0E20FD}"/>
                  </a:ext>
                </a:extLst>
              </p:cNvPr>
              <p:cNvSpPr/>
              <p:nvPr/>
            </p:nvSpPr>
            <p:spPr>
              <a:xfrm>
                <a:off x="7119607" y="1548758"/>
                <a:ext cx="1988928" cy="295811"/>
              </a:xfrm>
              <a:prstGeom prst="roundRect">
                <a:avLst/>
              </a:prstGeom>
              <a:solidFill>
                <a:srgbClr val="D1B2E8"/>
              </a:solidFill>
              <a:ln w="25400">
                <a:solidFill>
                  <a:srgbClr val="7030A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7030A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Archival biopsy</a:t>
                </a:r>
              </a:p>
            </p:txBody>
          </p:sp>
          <p:sp>
            <p:nvSpPr>
              <p:cNvPr id="59" name="Rounded Rectangle 58">
                <a:extLst>
                  <a:ext uri="{FF2B5EF4-FFF2-40B4-BE49-F238E27FC236}">
                    <a16:creationId xmlns:a16="http://schemas.microsoft.com/office/drawing/2014/main" id="{04ABD60F-43AB-4CB3-931F-DBB73C558959}"/>
                  </a:ext>
                </a:extLst>
              </p:cNvPr>
              <p:cNvSpPr/>
              <p:nvPr/>
            </p:nvSpPr>
            <p:spPr>
              <a:xfrm>
                <a:off x="7119606" y="3292202"/>
                <a:ext cx="1988928" cy="295811"/>
              </a:xfrm>
              <a:prstGeom prst="roundRect">
                <a:avLst/>
              </a:prstGeom>
              <a:solidFill>
                <a:srgbClr val="D1B2E8"/>
              </a:solidFill>
              <a:ln w="25400">
                <a:solidFill>
                  <a:srgbClr val="7030A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7030A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Serial blood tests</a:t>
                </a:r>
              </a:p>
            </p:txBody>
          </p:sp>
          <p:sp>
            <p:nvSpPr>
              <p:cNvPr id="65" name="Rounded Rectangle 64">
                <a:extLst>
                  <a:ext uri="{FF2B5EF4-FFF2-40B4-BE49-F238E27FC236}">
                    <a16:creationId xmlns:a16="http://schemas.microsoft.com/office/drawing/2014/main" id="{FF6EB22B-7EC8-4AC1-A2F4-E20DE298971E}"/>
                  </a:ext>
                </a:extLst>
              </p:cNvPr>
              <p:cNvSpPr/>
              <p:nvPr/>
            </p:nvSpPr>
            <p:spPr>
              <a:xfrm>
                <a:off x="258397" y="-356901"/>
                <a:ext cx="2660623" cy="545541"/>
              </a:xfrm>
              <a:prstGeom prst="round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2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PLATFORM</a:t>
                </a:r>
              </a:p>
            </p:txBody>
          </p:sp>
          <p:sp>
            <p:nvSpPr>
              <p:cNvPr id="66" name="Rounded Rectangle 65">
                <a:extLst>
                  <a:ext uri="{FF2B5EF4-FFF2-40B4-BE49-F238E27FC236}">
                    <a16:creationId xmlns:a16="http://schemas.microsoft.com/office/drawing/2014/main" id="{7FE72601-AE9A-434B-978B-1474B22FD598}"/>
                  </a:ext>
                </a:extLst>
              </p:cNvPr>
              <p:cNvSpPr/>
              <p:nvPr/>
            </p:nvSpPr>
            <p:spPr>
              <a:xfrm>
                <a:off x="258396" y="6144422"/>
                <a:ext cx="10518112" cy="809016"/>
              </a:xfrm>
              <a:prstGeom prst="roundRect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Primary endpoint: Progression-free survival	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7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Secondary endpoints: Overall survival, overall response rate, progression-free rate at 12 weeks, toxicity</a:t>
                </a:r>
              </a:p>
            </p:txBody>
          </p:sp>
          <p:cxnSp>
            <p:nvCxnSpPr>
              <p:cNvPr id="69" name="Straight Arrow Connector 68">
                <a:extLst>
                  <a:ext uri="{FF2B5EF4-FFF2-40B4-BE49-F238E27FC236}">
                    <a16:creationId xmlns:a16="http://schemas.microsoft.com/office/drawing/2014/main" id="{C5C661D3-96AB-4375-82BD-3BAC5E98764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62866" y="1962978"/>
                <a:ext cx="1331" cy="544088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F1077327-AA0E-46D5-BACA-406700DDFEFF}"/>
                  </a:ext>
                </a:extLst>
              </p:cNvPr>
              <p:cNvSpPr txBox="1"/>
              <p:nvPr/>
            </p:nvSpPr>
            <p:spPr>
              <a:xfrm>
                <a:off x="5490035" y="3060007"/>
                <a:ext cx="192585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Stratification factors: centre region, 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disease extent, PS</a:t>
                </a:r>
              </a:p>
            </p:txBody>
          </p:sp>
          <p:sp>
            <p:nvSpPr>
              <p:cNvPr id="55" name="Rounded Rectangle 4">
                <a:extLst>
                  <a:ext uri="{FF2B5EF4-FFF2-40B4-BE49-F238E27FC236}">
                    <a16:creationId xmlns:a16="http://schemas.microsoft.com/office/drawing/2014/main" id="{72C24763-F115-43D2-8BCE-ED05980F8104}"/>
                  </a:ext>
                </a:extLst>
              </p:cNvPr>
              <p:cNvSpPr/>
              <p:nvPr/>
            </p:nvSpPr>
            <p:spPr>
              <a:xfrm>
                <a:off x="1028291" y="1417720"/>
                <a:ext cx="1925857" cy="545259"/>
              </a:xfrm>
              <a:prstGeom prst="round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REGISTRATION</a:t>
                </a:r>
              </a:p>
            </p:txBody>
          </p:sp>
          <p:cxnSp>
            <p:nvCxnSpPr>
              <p:cNvPr id="67" name="Straight Arrow Connector 66">
                <a:extLst>
                  <a:ext uri="{FF2B5EF4-FFF2-40B4-BE49-F238E27FC236}">
                    <a16:creationId xmlns:a16="http://schemas.microsoft.com/office/drawing/2014/main" id="{CB3CA07A-8E19-4F2D-BC2A-EC04C5DE637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350560" y="1032122"/>
                <a:ext cx="1" cy="391110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Rounded Rectangle 12">
                <a:extLst>
                  <a:ext uri="{FF2B5EF4-FFF2-40B4-BE49-F238E27FC236}">
                    <a16:creationId xmlns:a16="http://schemas.microsoft.com/office/drawing/2014/main" id="{46FCC079-5812-4AA3-B697-27F32EB7C9FD}"/>
                  </a:ext>
                </a:extLst>
              </p:cNvPr>
              <p:cNvSpPr/>
              <p:nvPr/>
            </p:nvSpPr>
            <p:spPr>
              <a:xfrm>
                <a:off x="3837849" y="1433768"/>
                <a:ext cx="3025421" cy="534068"/>
              </a:xfrm>
              <a:prstGeom prst="roundRect">
                <a:avLst/>
              </a:prstGeom>
              <a:solidFill>
                <a:srgbClr val="55CBBD"/>
              </a:solidFill>
              <a:ln>
                <a:solidFill>
                  <a:srgbClr val="2F998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Platinum-fluoropyrimidine chemotherapy</a:t>
                </a:r>
              </a:p>
            </p:txBody>
          </p:sp>
          <p:sp>
            <p:nvSpPr>
              <p:cNvPr id="73" name="Rounded Rectangle 4">
                <a:extLst>
                  <a:ext uri="{FF2B5EF4-FFF2-40B4-BE49-F238E27FC236}">
                    <a16:creationId xmlns:a16="http://schemas.microsoft.com/office/drawing/2014/main" id="{6BEF1F98-91A9-4F4E-812E-39843FFADDA4}"/>
                  </a:ext>
                </a:extLst>
              </p:cNvPr>
              <p:cNvSpPr/>
              <p:nvPr/>
            </p:nvSpPr>
            <p:spPr>
              <a:xfrm>
                <a:off x="1022789" y="3084131"/>
                <a:ext cx="1925857" cy="545259"/>
              </a:xfrm>
              <a:prstGeom prst="round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RANDOMISATION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AC16790-7C38-44E6-B7DD-336F5C3EE75A}"/>
                  </a:ext>
                </a:extLst>
              </p:cNvPr>
              <p:cNvSpPr txBox="1"/>
              <p:nvPr/>
            </p:nvSpPr>
            <p:spPr>
              <a:xfrm>
                <a:off x="3313030" y="3302193"/>
                <a:ext cx="192585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+mn-ea"/>
                    <a:cs typeface="+mn-cs"/>
                  </a:rPr>
                  <a:t>1:1:1:1:1</a:t>
                </a:r>
              </a:p>
            </p:txBody>
          </p:sp>
          <p:cxnSp>
            <p:nvCxnSpPr>
              <p:cNvPr id="83" name="Straight Arrow Connector 82">
                <a:extLst>
                  <a:ext uri="{FF2B5EF4-FFF2-40B4-BE49-F238E27FC236}">
                    <a16:creationId xmlns:a16="http://schemas.microsoft.com/office/drawing/2014/main" id="{54F602E1-5F3F-4BFC-B8DC-E42F9777AB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87766" y="4852068"/>
                <a:ext cx="0" cy="737173"/>
              </a:xfrm>
              <a:prstGeom prst="straightConnector1">
                <a:avLst/>
              </a:prstGeom>
              <a:ln w="25400">
                <a:solidFill>
                  <a:srgbClr val="CC2E6A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C2EFC659-392E-46CD-99A5-E15CE244319D}"/>
                  </a:ext>
                </a:extLst>
              </p:cNvPr>
              <p:cNvCxnSpPr>
                <a:cxnSpLocks/>
                <a:stCxn id="22" idx="2"/>
              </p:cNvCxnSpPr>
              <p:nvPr/>
            </p:nvCxnSpPr>
            <p:spPr>
              <a:xfrm flipH="1">
                <a:off x="1559496" y="4852068"/>
                <a:ext cx="1704" cy="449141"/>
              </a:xfrm>
              <a:prstGeom prst="line">
                <a:avLst/>
              </a:prstGeom>
              <a:ln w="25400">
                <a:solidFill>
                  <a:srgbClr val="CC2E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Straight Connector 92">
                <a:extLst>
                  <a:ext uri="{FF2B5EF4-FFF2-40B4-BE49-F238E27FC236}">
                    <a16:creationId xmlns:a16="http://schemas.microsoft.com/office/drawing/2014/main" id="{24D9AEC7-EA24-4140-B60F-33D543EE25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1704" y="4852068"/>
                <a:ext cx="0" cy="449141"/>
              </a:xfrm>
              <a:prstGeom prst="line">
                <a:avLst/>
              </a:prstGeom>
              <a:ln w="25400">
                <a:solidFill>
                  <a:srgbClr val="CC2E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>
                <a:extLst>
                  <a:ext uri="{FF2B5EF4-FFF2-40B4-BE49-F238E27FC236}">
                    <a16:creationId xmlns:a16="http://schemas.microsoft.com/office/drawing/2014/main" id="{FCA09759-1622-4B9A-AACC-B6AF9A125E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20136" y="4814652"/>
                <a:ext cx="0" cy="486557"/>
              </a:xfrm>
              <a:prstGeom prst="line">
                <a:avLst/>
              </a:prstGeom>
              <a:ln w="25400">
                <a:solidFill>
                  <a:srgbClr val="CC2E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2F1779E1-7CBC-427B-8DF9-C543ABAB9EF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64352" y="4814652"/>
                <a:ext cx="0" cy="486557"/>
              </a:xfrm>
              <a:prstGeom prst="line">
                <a:avLst/>
              </a:prstGeom>
              <a:ln w="25400">
                <a:solidFill>
                  <a:srgbClr val="CC2E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33BFF5EE-F814-40E7-AB92-DAF7D81C8F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59496" y="5301208"/>
                <a:ext cx="7704856" cy="0"/>
              </a:xfrm>
              <a:prstGeom prst="line">
                <a:avLst/>
              </a:prstGeom>
              <a:ln w="25400">
                <a:solidFill>
                  <a:srgbClr val="CC2E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Rectangle: Rounded Corners 38">
                <a:extLst>
                  <a:ext uri="{FF2B5EF4-FFF2-40B4-BE49-F238E27FC236}">
                    <a16:creationId xmlns:a16="http://schemas.microsoft.com/office/drawing/2014/main" id="{A8979088-66E4-453E-9F38-AC00C62A4544}"/>
                  </a:ext>
                </a:extLst>
              </p:cNvPr>
              <p:cNvSpPr/>
              <p:nvPr/>
            </p:nvSpPr>
            <p:spPr>
              <a:xfrm>
                <a:off x="5516530" y="4981433"/>
                <a:ext cx="1587582" cy="275064"/>
              </a:xfrm>
              <a:prstGeom prst="roundRect">
                <a:avLst/>
              </a:prstGeom>
              <a:solidFill>
                <a:srgbClr val="FBFB7D"/>
              </a:solidFill>
              <a:ln>
                <a:solidFill>
                  <a:srgbClr val="CBDC28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12-weekly CT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334590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black and red lines&#10;&#10;AI-generated content may be incorrect.">
            <a:extLst>
              <a:ext uri="{FF2B5EF4-FFF2-40B4-BE49-F238E27FC236}">
                <a16:creationId xmlns:a16="http://schemas.microsoft.com/office/drawing/2014/main" id="{7678714F-0F52-E8BD-FC8F-56FCCD841F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4560" y="79608"/>
            <a:ext cx="9042880" cy="6698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2980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with black and white text&#10;&#10;AI-generated content may be incorrect.">
            <a:extLst>
              <a:ext uri="{FF2B5EF4-FFF2-40B4-BE49-F238E27FC236}">
                <a16:creationId xmlns:a16="http://schemas.microsoft.com/office/drawing/2014/main" id="{ACC7A48D-A4E5-2F5A-E97C-56322D0888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800" y="0"/>
            <a:ext cx="926239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04733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29760A-BE2A-8240-44C3-19D40C4D3B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0E61922-BAA9-F690-3DB7-DA42A458697A}"/>
              </a:ext>
            </a:extLst>
          </p:cNvPr>
          <p:cNvGrpSpPr/>
          <p:nvPr/>
        </p:nvGrpSpPr>
        <p:grpSpPr>
          <a:xfrm>
            <a:off x="206408" y="637323"/>
            <a:ext cx="5889591" cy="3835286"/>
            <a:chOff x="375374" y="225778"/>
            <a:chExt cx="5023555" cy="3014133"/>
          </a:xfrm>
        </p:grpSpPr>
        <p:pic>
          <p:nvPicPr>
            <p:cNvPr id="6" name="Picture 5" descr="A graph of a number and a graph of a number&#10;&#10;AI-generated content may be incorrect.">
              <a:extLst>
                <a:ext uri="{FF2B5EF4-FFF2-40B4-BE49-F238E27FC236}">
                  <a16:creationId xmlns:a16="http://schemas.microsoft.com/office/drawing/2014/main" id="{C6679E67-3A89-0D9F-A53F-8EE3433684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5374" y="225778"/>
              <a:ext cx="5023555" cy="301413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6C5E955-60F7-450B-6B53-F9B94C76256C}"/>
                </a:ext>
              </a:extLst>
            </p:cNvPr>
            <p:cNvSpPr txBox="1"/>
            <p:nvPr/>
          </p:nvSpPr>
          <p:spPr>
            <a:xfrm>
              <a:off x="497941" y="371192"/>
              <a:ext cx="3621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A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76BE9EF1-27D3-2E36-9E15-0227241B847F}"/>
              </a:ext>
            </a:extLst>
          </p:cNvPr>
          <p:cNvGrpSpPr/>
          <p:nvPr/>
        </p:nvGrpSpPr>
        <p:grpSpPr>
          <a:xfrm>
            <a:off x="5866220" y="812282"/>
            <a:ext cx="5861954" cy="3531117"/>
            <a:chOff x="216526" y="3385325"/>
            <a:chExt cx="5341250" cy="3204750"/>
          </a:xfrm>
        </p:grpSpPr>
        <p:pic>
          <p:nvPicPr>
            <p:cNvPr id="8" name="Picture 7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67EEC0BF-045D-730A-DE8E-729E85C5DA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526" y="3385325"/>
              <a:ext cx="5341250" cy="3204750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233CE5B-AA5A-AE57-1973-3793C452E6B8}"/>
                </a:ext>
              </a:extLst>
            </p:cNvPr>
            <p:cNvSpPr txBox="1"/>
            <p:nvPr/>
          </p:nvSpPr>
          <p:spPr>
            <a:xfrm>
              <a:off x="497941" y="3466790"/>
              <a:ext cx="3621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7424656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123</Words>
  <Application>Microsoft Office PowerPoint</Application>
  <PresentationFormat>Widescreen</PresentationFormat>
  <Paragraphs>37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roline Fong</dc:creator>
  <cp:lastModifiedBy>Ian Chau</cp:lastModifiedBy>
  <cp:revision>6</cp:revision>
  <dcterms:created xsi:type="dcterms:W3CDTF">2024-08-07T17:58:41Z</dcterms:created>
  <dcterms:modified xsi:type="dcterms:W3CDTF">2026-04-16T19:27:08Z</dcterms:modified>
</cp:coreProperties>
</file>